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8" d="100"/>
          <a:sy n="88" d="100"/>
        </p:scale>
        <p:origin x="62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4252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1651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32405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7582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180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8907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7234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3677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1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2364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0599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D96E3A-E375-46DA-812F-54460AA76E1D}" type="datetimeFigureOut">
              <a:rPr lang="zh-CN" altLang="en-US" smtClean="0"/>
              <a:t>2016/5/23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09E8E3-1FBE-4082-A1C8-CD5BD026F9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0778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1820882"/>
              </p:ext>
            </p:extLst>
          </p:nvPr>
        </p:nvGraphicFramePr>
        <p:xfrm>
          <a:off x="522515" y="1905000"/>
          <a:ext cx="10918371" cy="1662290"/>
        </p:xfrm>
        <a:graphic>
          <a:graphicData uri="http://schemas.openxmlformats.org/drawingml/2006/table">
            <a:tbl>
              <a:tblPr/>
              <a:tblGrid>
                <a:gridCol w="1132112"/>
                <a:gridCol w="1796145"/>
                <a:gridCol w="1643743"/>
                <a:gridCol w="1676400"/>
                <a:gridCol w="1817914"/>
                <a:gridCol w="1513114"/>
                <a:gridCol w="1338943"/>
              </a:tblGrid>
              <a:tr h="78128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800" b="0" i="0" u="none" strike="noStrike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aterial</a:t>
                      </a:r>
                      <a:endParaRPr lang="zh-CN" altLang="en-US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Plant height (cm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Effective panicle number per pla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rain number per panic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Filled grain number per panic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Seed setting rate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housand-grain </a:t>
                      </a:r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weight (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96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W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11.79±1.23</a:t>
                      </a:r>
                      <a:endParaRPr lang="en-US" altLang="zh-CN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3.80±1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68.60±4.39</a:t>
                      </a:r>
                      <a:endParaRPr lang="en-US" altLang="zh-CN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40.20±3.7</a:t>
                      </a:r>
                      <a:endParaRPr lang="en-US" altLang="zh-CN" sz="1800" b="0" i="0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80.78±1.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6.46±0.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701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0" i="1" u="none" strike="noStrike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ygl8</a:t>
                      </a:r>
                      <a:endParaRPr lang="en-US" sz="1800" b="0" i="1" u="none" strike="noStrike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02.53±1.69</a:t>
                      </a:r>
                      <a:r>
                        <a:rPr lang="en-US" altLang="zh-CN" sz="1800" b="0" i="0" u="none" strike="noStrike" baseline="3000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b="0" i="0" u="none" strike="noStrike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9.80±1.64</a:t>
                      </a:r>
                      <a:r>
                        <a:rPr lang="en-US" altLang="zh-CN" sz="1800" b="0" i="0" u="none" strike="noStrike" baseline="30000" dirty="0" smtClean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**</a:t>
                      </a:r>
                      <a:endParaRPr lang="en-US" altLang="zh-CN" sz="1800" b="0" i="0" u="none" strike="noStrike" baseline="300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b="0" i="0" u="none" strike="noStrike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43.47±10.22</a:t>
                      </a:r>
                      <a:r>
                        <a:rPr lang="en-US" altLang="zh-CN" sz="1800" b="0" i="0" u="none" strike="noStrike" baseline="30000" dirty="0" smtClean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**</a:t>
                      </a:r>
                      <a:endParaRPr lang="en-US" altLang="zh-CN" sz="1800" b="0" i="0" u="none" strike="noStrike" baseline="300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b="0" i="0" u="none" strike="noStrike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10.88±4.65</a:t>
                      </a:r>
                      <a:r>
                        <a:rPr lang="en-US" altLang="zh-CN" sz="1800" b="0" i="0" u="none" strike="noStrike" baseline="30000" dirty="0" smtClean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**</a:t>
                      </a:r>
                      <a:endParaRPr lang="en-US" altLang="zh-CN" sz="1800" b="0" i="0" u="none" strike="noStrike" baseline="300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b="0" i="0" u="none" strike="noStrike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74.07±2.8</a:t>
                      </a:r>
                      <a:r>
                        <a:rPr lang="en-US" altLang="zh-CN" sz="1800" b="0" i="0" u="none" strike="noStrike" baseline="30000" dirty="0" smtClean="0"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**</a:t>
                      </a:r>
                      <a:endParaRPr lang="en-US" altLang="zh-CN" sz="1800" b="0" i="0" u="none" strike="noStrike" baseline="300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800" b="0" i="0" u="none" strike="noStrike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5.46±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矩形 6"/>
          <p:cNvSpPr/>
          <p:nvPr/>
        </p:nvSpPr>
        <p:spPr>
          <a:xfrm>
            <a:off x="2654649" y="1459079"/>
            <a:ext cx="59683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Statistics of agronomic traits of the wild-type and </a:t>
            </a:r>
            <a:r>
              <a:rPr lang="en-US" altLang="zh-CN" i="1" dirty="0">
                <a:latin typeface="Times New Roman" panose="02020603050405020304" pitchFamily="18" charset="0"/>
              </a:rPr>
              <a:t>ygl8</a:t>
            </a:r>
            <a:r>
              <a:rPr lang="en-US" altLang="zh-CN" dirty="0">
                <a:latin typeface="Times New Roman" panose="02020603050405020304" pitchFamily="18" charset="0"/>
              </a:rPr>
              <a:t> mutant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081361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59</Words>
  <Application>Microsoft Office PowerPoint</Application>
  <PresentationFormat>宽屏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微软中国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微软用户</dc:creator>
  <cp:lastModifiedBy>微软用户</cp:lastModifiedBy>
  <cp:revision>8</cp:revision>
  <dcterms:created xsi:type="dcterms:W3CDTF">2016-05-19T14:04:04Z</dcterms:created>
  <dcterms:modified xsi:type="dcterms:W3CDTF">2016-05-23T09:59:09Z</dcterms:modified>
</cp:coreProperties>
</file>